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775"/>
  </p:normalViewPr>
  <p:slideViewPr>
    <p:cSldViewPr snapToGrid="0">
      <p:cViewPr varScale="1">
        <p:scale>
          <a:sx n="105" d="100"/>
          <a:sy n="105" d="100"/>
        </p:scale>
        <p:origin x="8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A82D35-106D-6C2D-BEB3-8801642193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FDAA11-F2C2-21C3-119F-DA339FC6BF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0D59AD-710B-DDE4-ABF3-61B10D884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535256-C6D1-D493-036F-70AE4296A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964826-F77E-B5D7-8F7A-2F7FBD716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03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0EF637-1210-B340-B8EC-1445ACDDC0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99E647-8C24-8CB7-E081-A85FB58D0F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9B7DA9-A379-2B29-CCAC-F97367F1A2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474D16-F896-2003-AA69-174873C18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6BF1CC-E861-711B-2B2B-FC302B63D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162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B20FDCD-9D22-2889-A6A1-F870F86E62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BA5C6C-200D-CFCC-29BE-B61FD89CA4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865589-82B9-EF53-BCDD-7D87E99E8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B1DB2E-A95E-03F3-20C7-1D764A429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A7B4C1-4DF0-9B73-EE81-94F3530D6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372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48F0FA-4132-C6E7-26D4-D79261DB06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FC555F-2E42-60D0-75B3-A0C1FAFF97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65115A-959A-93C2-845B-E7B60B3DE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38DEC6-6F3E-F9EA-A600-86BB00A9A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3E798B-701E-B7EC-B737-C36441C71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970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95F657-1C45-578E-9DF1-756D988116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221302-E80C-9956-8E4B-C245E1AE59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DD436E-F54C-E8F4-4A04-509A09C3D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5CBA29-04CC-FDB0-90DE-6FE277371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9CC8AA-163F-C662-3940-61FC3870A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589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0D103B-6D6E-FCC3-324C-D7D0C73383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2F5598-FE42-2DFD-44AA-D336E0B1AE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27C338-7862-6D13-B277-3192A1D171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455AC4-0B41-A293-E64A-FF0424501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D79658-E07F-B397-3985-396182437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E288A6-DF39-D6B7-B1DA-53DC53B373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56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1DAD06-FCE1-389C-7ED1-F8000F4E21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561501-FA9D-2FDE-5D11-C60804BA0D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385CE2-DAC5-7F19-D306-8C8BF31659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24EA12-01FB-E5F8-37E3-FB871E500E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DE3B68-A3D7-766F-E498-A9CA7F9F03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624F5F3-8031-1DA8-4441-5BFCBD130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8B8211-8F8F-4DFB-250C-5111C76EE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116D9C-8C29-E049-3599-CB4C1A58E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8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FD765-83E2-B95D-56F1-9EAA505418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07B84F-8203-939E-2787-E8D98BF36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ACB6DC-CDF9-71C9-E5D7-A6555670C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276005-CB52-A03E-B61E-C67732A2C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9192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718FA5-6FA0-CBAA-CC42-91F1C5CAB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79B8A4-C318-158C-BA39-EFE75FBD2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CC0596A-5ED9-C677-AD57-DC32389CE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334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3230C-47E2-9CD4-E5C6-B9941A51C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927B68-53CD-E45A-845F-9B7C0D7CD2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61D9EB-ECF9-01A7-D221-E8E8CD9A76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A60295-9876-71C0-9B4D-AE96FB1A6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761009-46E2-7ABE-FA64-6C961E81E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2D24C4-D905-94AF-819F-5E55CFBB31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92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4C225-8DCD-725C-07A0-BEEEB93C9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645337D-171B-0A52-E3EE-CFDB77BBB6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5249D3-3867-C625-258B-04DCA21E45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6EA72E-83DE-F844-2C70-39EF29842F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65C267-16A3-B1A2-B4F5-6898EBBF1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213A1D-D4BC-CAF5-A89D-C1E014083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748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611171-2D18-8D26-0AD6-78BF94C3A3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F9EFCC-53AA-940E-4984-5AE9C6F9E3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38401F-73F9-FFD1-494D-2FB5A45C47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6EEC2-A607-944B-8A01-E8E3F34E814C}" type="datetimeFigureOut">
              <a:rPr lang="en-US" smtClean="0"/>
              <a:t>3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1B9F39-F2CC-4F54-B153-78BA24CB21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84A71B-979B-7A46-E27A-0A0A3827C4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B090F-43E2-914A-B9C1-1581B8C30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193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105F932-436F-4922-6310-8293D4DC95C3}"/>
              </a:ext>
            </a:extLst>
          </p:cNvPr>
          <p:cNvGrpSpPr/>
          <p:nvPr/>
        </p:nvGrpSpPr>
        <p:grpSpPr>
          <a:xfrm>
            <a:off x="228600" y="1701609"/>
            <a:ext cx="9418320" cy="2827021"/>
            <a:chOff x="0" y="-84292"/>
            <a:chExt cx="11872451" cy="3909041"/>
          </a:xfrm>
        </p:grpSpPr>
        <p:pic>
          <p:nvPicPr>
            <p:cNvPr id="5" name="Picture 4" descr="A screen shot of a graph&#10;&#10;Description automatically generated">
              <a:extLst>
                <a:ext uri="{FF2B5EF4-FFF2-40B4-BE49-F238E27FC236}">
                  <a16:creationId xmlns:a16="http://schemas.microsoft.com/office/drawing/2014/main" id="{68F1A322-2E8B-776F-9833-96F985ECCE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5565" t="2961" b="2352"/>
            <a:stretch/>
          </p:blipFill>
          <p:spPr>
            <a:xfrm>
              <a:off x="1578077" y="9833"/>
              <a:ext cx="10294374" cy="3814916"/>
            </a:xfrm>
            <a:prstGeom prst="rect">
              <a:avLst/>
            </a:prstGeom>
          </p:spPr>
        </p:pic>
        <p:pic>
          <p:nvPicPr>
            <p:cNvPr id="6" name="Picture 5" descr="A screen shot of a graph&#10;&#10;Description automatically generated">
              <a:extLst>
                <a:ext uri="{FF2B5EF4-FFF2-40B4-BE49-F238E27FC236}">
                  <a16:creationId xmlns:a16="http://schemas.microsoft.com/office/drawing/2014/main" id="{655DA70F-3AC4-A556-33FD-1811A5245D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961" r="86976" b="2352"/>
            <a:stretch/>
          </p:blipFill>
          <p:spPr>
            <a:xfrm>
              <a:off x="0" y="9832"/>
              <a:ext cx="1587909" cy="381491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1E0C8C1-4E07-94EE-0842-C5119D69FB1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83211" y="9832"/>
              <a:ext cx="1420491" cy="2176461"/>
            </a:xfrm>
            <a:prstGeom prst="rect">
              <a:avLst/>
            </a:prstGeom>
          </p:spPr>
        </p:pic>
        <p:sp>
          <p:nvSpPr>
            <p:cNvPr id="8" name="TextBox 5">
              <a:extLst>
                <a:ext uri="{FF2B5EF4-FFF2-40B4-BE49-F238E27FC236}">
                  <a16:creationId xmlns:a16="http://schemas.microsoft.com/office/drawing/2014/main" id="{5F57FEF6-E87F-682A-2A96-9A8900AB4419}"/>
                </a:ext>
              </a:extLst>
            </p:cNvPr>
            <p:cNvSpPr txBox="1"/>
            <p:nvPr/>
          </p:nvSpPr>
          <p:spPr>
            <a:xfrm>
              <a:off x="7918874" y="-84292"/>
              <a:ext cx="1061720" cy="30555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lang="en-CA" sz="85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ST DK03-33</a:t>
              </a:r>
              <a:endParaRPr lang="en-CA" sz="1200" kern="10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562924D5-9036-19C6-4DC9-DCEFA430D0A1}"/>
              </a:ext>
            </a:extLst>
          </p:cNvPr>
          <p:cNvSpPr txBox="1"/>
          <p:nvPr/>
        </p:nvSpPr>
        <p:spPr>
          <a:xfrm>
            <a:off x="228600" y="4596701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4. </a:t>
            </a:r>
            <a:r>
              <a:rPr lang="en-CA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NA integrity test of HMW PST and PSH DNA samples on </a:t>
            </a:r>
            <a:r>
              <a:rPr lang="en-CA" sz="18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peStation</a:t>
            </a:r>
            <a:r>
              <a:rPr lang="en-CA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66148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lden, Samuel</dc:creator>
  <cp:lastModifiedBy>Holden, Samuel</cp:lastModifiedBy>
  <cp:revision>1</cp:revision>
  <dcterms:created xsi:type="dcterms:W3CDTF">2025-03-28T20:14:41Z</dcterms:created>
  <dcterms:modified xsi:type="dcterms:W3CDTF">2025-03-28T20:15:17Z</dcterms:modified>
</cp:coreProperties>
</file>